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9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792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hwsedero" initials="h" lastIdx="2" clrIdx="0"/>
  <p:cmAuthor id="1" name="Soundarya Srirangan" initials="SS" lastIdx="9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CEC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43" autoAdjust="0"/>
    <p:restoredTop sz="99856" autoAdjust="0"/>
  </p:normalViewPr>
  <p:slideViewPr>
    <p:cSldViewPr>
      <p:cViewPr varScale="1">
        <p:scale>
          <a:sx n="53" d="100"/>
          <a:sy n="53" d="100"/>
        </p:scale>
        <p:origin x="1952" y="48"/>
      </p:cViewPr>
      <p:guideLst>
        <p:guide orient="horz" pos="3792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53" d="100"/>
          <a:sy n="53" d="100"/>
        </p:scale>
        <p:origin x="2624" y="28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NCSU\Patrick\Publication%20-%20Data\For%20The%20Paper\HE%20Gene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NCSU\Patrick\Publication%20-%20Data\For%20The%20Paper\HE%20Gene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NCSU\Patrick\Publication%20-%20Data\For%20The%20Paper\HE%20Gen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800">
                <a:latin typeface="Helvetica" panose="020B0604020202020204" pitchFamily="34" charset="0"/>
                <a:cs typeface="Helvetica" panose="020B0604020202020204" pitchFamily="34" charset="0"/>
              </a:defRPr>
            </a:pPr>
            <a:r>
              <a:rPr lang="en-US" sz="800">
                <a:latin typeface="Helvetica" panose="020B0604020202020204" pitchFamily="34" charset="0"/>
                <a:cs typeface="Helvetica" panose="020B0604020202020204" pitchFamily="34" charset="0"/>
              </a:rPr>
              <a:t>Adenylate Cyclase</a:t>
            </a:r>
          </a:p>
        </c:rich>
      </c:tx>
      <c:layout>
        <c:manualLayout>
          <c:xMode val="edge"/>
          <c:yMode val="edge"/>
          <c:x val="0.25525583081725894"/>
          <c:y val="6.7336832895888044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9869766570818817"/>
          <c:y val="3.5071952212869968E-2"/>
          <c:w val="0.75175276716775452"/>
          <c:h val="0.7981274323468189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R$8</c:f>
              <c:strCache>
                <c:ptCount val="1"/>
                <c:pt idx="0">
                  <c:v>Adenylate Cyclase Real Time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S$10:$X$10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30972000000000011</c:v>
                  </c:pt>
                  <c:pt idx="2">
                    <c:v>0.67806999999999995</c:v>
                  </c:pt>
                  <c:pt idx="3">
                    <c:v>1.8889</c:v>
                  </c:pt>
                  <c:pt idx="4">
                    <c:v>2.3899999999999997</c:v>
                  </c:pt>
                  <c:pt idx="5">
                    <c:v>3.2858700000000001</c:v>
                  </c:pt>
                </c:numCache>
              </c:numRef>
            </c:plus>
            <c:minus>
              <c:numRef>
                <c:f>Sheet1!$S$10:$X$10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30972000000000011</c:v>
                  </c:pt>
                  <c:pt idx="2">
                    <c:v>0.67806999999999995</c:v>
                  </c:pt>
                  <c:pt idx="3">
                    <c:v>1.8889</c:v>
                  </c:pt>
                  <c:pt idx="4">
                    <c:v>2.3899999999999997</c:v>
                  </c:pt>
                  <c:pt idx="5">
                    <c:v>3.2858700000000001</c:v>
                  </c:pt>
                </c:numCache>
              </c:numRef>
            </c:minus>
          </c:errBars>
          <c:cat>
            <c:multiLvlStrRef>
              <c:f>Sheet1!$S$6:$X$7</c:f>
              <c:multiLvlStrCache>
                <c:ptCount val="6"/>
                <c:lvl>
                  <c:pt idx="0">
                    <c:v>30h</c:v>
                  </c:pt>
                  <c:pt idx="1">
                    <c:v>40h</c:v>
                  </c:pt>
                  <c:pt idx="2">
                    <c:v>54h</c:v>
                  </c:pt>
                  <c:pt idx="3">
                    <c:v>30h</c:v>
                  </c:pt>
                  <c:pt idx="4">
                    <c:v>40h</c:v>
                  </c:pt>
                  <c:pt idx="5">
                    <c:v>54h</c:v>
                  </c:pt>
                </c:lvl>
                <c:lvl>
                  <c:pt idx="0">
                    <c:v>25°C</c:v>
                  </c:pt>
                  <c:pt idx="3">
                    <c:v>35°C</c:v>
                  </c:pt>
                </c:lvl>
              </c:multiLvlStrCache>
            </c:multiLvlStrRef>
          </c:cat>
          <c:val>
            <c:numRef>
              <c:f>Sheet1!$S$8:$X$8</c:f>
              <c:numCache>
                <c:formatCode>General</c:formatCode>
                <c:ptCount val="6"/>
                <c:pt idx="0">
                  <c:v>1</c:v>
                </c:pt>
                <c:pt idx="1">
                  <c:v>1.6684053000000001</c:v>
                </c:pt>
                <c:pt idx="2">
                  <c:v>1.6334692999999996</c:v>
                </c:pt>
                <c:pt idx="3">
                  <c:v>3.846174</c:v>
                </c:pt>
                <c:pt idx="4">
                  <c:v>25.396992999999991</c:v>
                </c:pt>
                <c:pt idx="5">
                  <c:v>12.556023</c:v>
                </c:pt>
              </c:numCache>
            </c:numRef>
          </c:val>
        </c:ser>
        <c:ser>
          <c:idx val="1"/>
          <c:order val="1"/>
          <c:tx>
            <c:strRef>
              <c:f>Sheet1!$R$9</c:f>
              <c:strCache>
                <c:ptCount val="1"/>
                <c:pt idx="0">
                  <c:v>Adenylate Cyclase RNA Seq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multiLvlStrRef>
              <c:f>Sheet1!$S$6:$X$7</c:f>
              <c:multiLvlStrCache>
                <c:ptCount val="6"/>
                <c:lvl>
                  <c:pt idx="0">
                    <c:v>30h</c:v>
                  </c:pt>
                  <c:pt idx="1">
                    <c:v>40h</c:v>
                  </c:pt>
                  <c:pt idx="2">
                    <c:v>54h</c:v>
                  </c:pt>
                  <c:pt idx="3">
                    <c:v>30h</c:v>
                  </c:pt>
                  <c:pt idx="4">
                    <c:v>40h</c:v>
                  </c:pt>
                  <c:pt idx="5">
                    <c:v>54h</c:v>
                  </c:pt>
                </c:lvl>
                <c:lvl>
                  <c:pt idx="0">
                    <c:v>25°C</c:v>
                  </c:pt>
                  <c:pt idx="3">
                    <c:v>35°C</c:v>
                  </c:pt>
                </c:lvl>
              </c:multiLvlStrCache>
            </c:multiLvlStrRef>
          </c:cat>
          <c:val>
            <c:numRef>
              <c:f>Sheet1!$S$9:$X$9</c:f>
              <c:numCache>
                <c:formatCode>General</c:formatCode>
                <c:ptCount val="6"/>
                <c:pt idx="0">
                  <c:v>1</c:v>
                </c:pt>
                <c:pt idx="1">
                  <c:v>0</c:v>
                </c:pt>
                <c:pt idx="2">
                  <c:v>2.9913995029999998</c:v>
                </c:pt>
                <c:pt idx="3">
                  <c:v>12.645155730000001</c:v>
                </c:pt>
                <c:pt idx="4">
                  <c:v>26.96041516</c:v>
                </c:pt>
                <c:pt idx="5">
                  <c:v>30.68898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3396912"/>
        <c:axId val="193398088"/>
      </c:barChart>
      <c:catAx>
        <c:axId val="19339691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en-US"/>
          </a:p>
        </c:txPr>
        <c:crossAx val="193398088"/>
        <c:crosses val="autoZero"/>
        <c:auto val="1"/>
        <c:lblAlgn val="ctr"/>
        <c:lblOffset val="100"/>
        <c:noMultiLvlLbl val="0"/>
      </c:catAx>
      <c:valAx>
        <c:axId val="19339808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 b="0">
                    <a:latin typeface="Helvetica" panose="020B0604020202020204" pitchFamily="34" charset="0"/>
                    <a:cs typeface="Helvetica" panose="020B0604020202020204" pitchFamily="34" charset="0"/>
                  </a:defRPr>
                </a:pPr>
                <a:r>
                  <a:rPr lang="en-US" sz="800" b="0">
                    <a:latin typeface="Helvetica" panose="020B0604020202020204" pitchFamily="34" charset="0"/>
                    <a:cs typeface="Helvetica" panose="020B0604020202020204" pitchFamily="34" charset="0"/>
                  </a:rPr>
                  <a:t>Expression Leve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19339691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800">
                <a:latin typeface="Helvetica" panose="020B0604020202020204" pitchFamily="34" charset="0"/>
                <a:cs typeface="Helvetica" panose="020B0604020202020204" pitchFamily="34" charset="0"/>
              </a:defRPr>
            </a:pPr>
            <a:r>
              <a:rPr lang="en-US" sz="800" dirty="0">
                <a:latin typeface="Helvetica" panose="020B0604020202020204" pitchFamily="34" charset="0"/>
                <a:cs typeface="Helvetica" panose="020B0604020202020204" pitchFamily="34" charset="0"/>
              </a:rPr>
              <a:t>Sodium Phosphate </a:t>
            </a:r>
            <a:r>
              <a:rPr lang="en-US" sz="800" dirty="0" err="1">
                <a:latin typeface="Helvetica" panose="020B0604020202020204" pitchFamily="34" charset="0"/>
                <a:cs typeface="Helvetica" panose="020B0604020202020204" pitchFamily="34" charset="0"/>
              </a:rPr>
              <a:t>Symporter</a:t>
            </a:r>
            <a:r>
              <a:rPr lang="en-US" sz="8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</a:p>
        </c:rich>
      </c:tx>
      <c:layout>
        <c:manualLayout>
          <c:xMode val="edge"/>
          <c:yMode val="edge"/>
          <c:x val="0.24908987138870098"/>
          <c:y val="7.8811414434626317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22171638957699613"/>
          <c:y val="3.5932408016568371E-2"/>
          <c:w val="0.77828361042300442"/>
          <c:h val="0.7931746877322503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R$23</c:f>
              <c:strCache>
                <c:ptCount val="1"/>
                <c:pt idx="0">
                  <c:v>Sodium Phosphate Symporter (15245) Real Time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S$30:$X$30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74105771991018266</c:v>
                  </c:pt>
                  <c:pt idx="2">
                    <c:v>0.93699947553018004</c:v>
                  </c:pt>
                  <c:pt idx="3">
                    <c:v>1.0201568216945367</c:v>
                  </c:pt>
                  <c:pt idx="4">
                    <c:v>4.1572248717257638</c:v>
                  </c:pt>
                  <c:pt idx="5">
                    <c:v>14.511367617574638</c:v>
                  </c:pt>
                </c:numCache>
              </c:numRef>
            </c:plus>
            <c:minus>
              <c:numRef>
                <c:f>Sheet1!$S$30:$X$30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74105771991018266</c:v>
                  </c:pt>
                  <c:pt idx="2">
                    <c:v>0.93699947553018004</c:v>
                  </c:pt>
                  <c:pt idx="3">
                    <c:v>1.0201568216945367</c:v>
                  </c:pt>
                  <c:pt idx="4">
                    <c:v>4.1572248717257638</c:v>
                  </c:pt>
                  <c:pt idx="5">
                    <c:v>14.511367617574638</c:v>
                  </c:pt>
                </c:numCache>
              </c:numRef>
            </c:minus>
          </c:errBars>
          <c:cat>
            <c:multiLvlStrRef>
              <c:f>Sheet1!$S$21:$X$22</c:f>
              <c:multiLvlStrCache>
                <c:ptCount val="6"/>
                <c:lvl>
                  <c:pt idx="0">
                    <c:v>30h</c:v>
                  </c:pt>
                  <c:pt idx="1">
                    <c:v>40h</c:v>
                  </c:pt>
                  <c:pt idx="2">
                    <c:v>54h</c:v>
                  </c:pt>
                  <c:pt idx="3">
                    <c:v>30h</c:v>
                  </c:pt>
                  <c:pt idx="4">
                    <c:v>40h</c:v>
                  </c:pt>
                  <c:pt idx="5">
                    <c:v>54h</c:v>
                  </c:pt>
                </c:lvl>
                <c:lvl>
                  <c:pt idx="0">
                    <c:v>25°C</c:v>
                  </c:pt>
                  <c:pt idx="3">
                    <c:v>35°C</c:v>
                  </c:pt>
                </c:lvl>
              </c:multiLvlStrCache>
            </c:multiLvlStrRef>
          </c:cat>
          <c:val>
            <c:numRef>
              <c:f>Sheet1!$S$23:$X$23</c:f>
              <c:numCache>
                <c:formatCode>General</c:formatCode>
                <c:ptCount val="6"/>
                <c:pt idx="0">
                  <c:v>1</c:v>
                </c:pt>
                <c:pt idx="1">
                  <c:v>1.2930352999999997</c:v>
                </c:pt>
                <c:pt idx="2">
                  <c:v>2.4375762999999999</c:v>
                </c:pt>
                <c:pt idx="3">
                  <c:v>2.8126882999999983</c:v>
                </c:pt>
                <c:pt idx="4">
                  <c:v>31.655246999999992</c:v>
                </c:pt>
                <c:pt idx="5">
                  <c:v>30.268299999999989</c:v>
                </c:pt>
              </c:numCache>
            </c:numRef>
          </c:val>
        </c:ser>
        <c:ser>
          <c:idx val="1"/>
          <c:order val="1"/>
          <c:tx>
            <c:strRef>
              <c:f>Sheet1!$R$24</c:f>
              <c:strCache>
                <c:ptCount val="1"/>
                <c:pt idx="0">
                  <c:v>Sodium Phosphate Symporter (15245) RNA Seq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multiLvlStrRef>
              <c:f>Sheet1!$S$21:$X$22</c:f>
              <c:multiLvlStrCache>
                <c:ptCount val="6"/>
                <c:lvl>
                  <c:pt idx="0">
                    <c:v>30h</c:v>
                  </c:pt>
                  <c:pt idx="1">
                    <c:v>40h</c:v>
                  </c:pt>
                  <c:pt idx="2">
                    <c:v>54h</c:v>
                  </c:pt>
                  <c:pt idx="3">
                    <c:v>30h</c:v>
                  </c:pt>
                  <c:pt idx="4">
                    <c:v>40h</c:v>
                  </c:pt>
                  <c:pt idx="5">
                    <c:v>54h</c:v>
                  </c:pt>
                </c:lvl>
                <c:lvl>
                  <c:pt idx="0">
                    <c:v>25°C</c:v>
                  </c:pt>
                  <c:pt idx="3">
                    <c:v>35°C</c:v>
                  </c:pt>
                </c:lvl>
              </c:multiLvlStrCache>
            </c:multiLvlStrRef>
          </c:cat>
          <c:val>
            <c:numRef>
              <c:f>Sheet1!$S$24:$X$24</c:f>
              <c:numCache>
                <c:formatCode>General</c:formatCode>
                <c:ptCount val="6"/>
                <c:pt idx="0">
                  <c:v>1</c:v>
                </c:pt>
                <c:pt idx="1">
                  <c:v>1.0849291759999995</c:v>
                </c:pt>
                <c:pt idx="2">
                  <c:v>1.8106773890000001</c:v>
                </c:pt>
                <c:pt idx="3">
                  <c:v>2.0994243859999999</c:v>
                </c:pt>
                <c:pt idx="4">
                  <c:v>28.05876224999999</c:v>
                </c:pt>
                <c:pt idx="5">
                  <c:v>49.8424672999999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3401224"/>
        <c:axId val="193398480"/>
      </c:barChart>
      <c:catAx>
        <c:axId val="1934012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en-US"/>
          </a:p>
        </c:txPr>
        <c:crossAx val="193398480"/>
        <c:crosses val="autoZero"/>
        <c:auto val="1"/>
        <c:lblAlgn val="ctr"/>
        <c:lblOffset val="100"/>
        <c:noMultiLvlLbl val="0"/>
      </c:catAx>
      <c:valAx>
        <c:axId val="19339848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 b="0">
                    <a:latin typeface="Helvetica" panose="020B0604020202020204" pitchFamily="34" charset="0"/>
                    <a:cs typeface="Helvetica" panose="020B0604020202020204" pitchFamily="34" charset="0"/>
                  </a:defRPr>
                </a:pPr>
                <a:r>
                  <a:rPr lang="en-US" sz="800" b="0">
                    <a:latin typeface="Helvetica" panose="020B0604020202020204" pitchFamily="34" charset="0"/>
                    <a:cs typeface="Helvetica" panose="020B0604020202020204" pitchFamily="34" charset="0"/>
                  </a:rPr>
                  <a:t>Expression Level</a:t>
                </a:r>
              </a:p>
            </c:rich>
          </c:tx>
          <c:layout>
            <c:manualLayout>
              <c:xMode val="edge"/>
              <c:yMode val="edge"/>
              <c:x val="3.2023716041255132E-2"/>
              <c:y val="0.2427346071800425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19340122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800">
                <a:latin typeface="Helvetica" panose="020B0604020202020204" pitchFamily="34" charset="0"/>
                <a:cs typeface="Helvetica" panose="020B0604020202020204" pitchFamily="34" charset="0"/>
              </a:defRPr>
            </a:pPr>
            <a:r>
              <a:rPr lang="en-US" sz="800">
                <a:latin typeface="Helvetica" panose="020B0604020202020204" pitchFamily="34" charset="0"/>
                <a:cs typeface="Helvetica" panose="020B0604020202020204" pitchFamily="34" charset="0"/>
              </a:rPr>
              <a:t>Triacylglycerol Lipase</a:t>
            </a:r>
          </a:p>
        </c:rich>
      </c:tx>
      <c:layout>
        <c:manualLayout>
          <c:xMode val="edge"/>
          <c:yMode val="edge"/>
          <c:x val="0.33058655267455267"/>
          <c:y val="3.842049415713527E-2"/>
        </c:manualLayout>
      </c:layout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R$18</c:f>
              <c:strCache>
                <c:ptCount val="1"/>
                <c:pt idx="0">
                  <c:v>Triacylglycerol Lipase Real Time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S$20:$X$20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87575000000000025</c:v>
                  </c:pt>
                  <c:pt idx="2">
                    <c:v>1.1962500000000005</c:v>
                  </c:pt>
                  <c:pt idx="3">
                    <c:v>0.92344000000000004</c:v>
                  </c:pt>
                  <c:pt idx="4">
                    <c:v>0.46521000000000001</c:v>
                  </c:pt>
                  <c:pt idx="5">
                    <c:v>0.73821000000000003</c:v>
                  </c:pt>
                </c:numCache>
              </c:numRef>
            </c:plus>
            <c:minus>
              <c:numRef>
                <c:f>Sheet1!$S$20:$X$20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87575000000000025</c:v>
                  </c:pt>
                  <c:pt idx="2">
                    <c:v>1.1962500000000005</c:v>
                  </c:pt>
                  <c:pt idx="3">
                    <c:v>0.92344000000000004</c:v>
                  </c:pt>
                  <c:pt idx="4">
                    <c:v>0.46521000000000001</c:v>
                  </c:pt>
                  <c:pt idx="5">
                    <c:v>0.73821000000000003</c:v>
                  </c:pt>
                </c:numCache>
              </c:numRef>
            </c:minus>
          </c:errBars>
          <c:cat>
            <c:multiLvlStrRef>
              <c:f>Sheet1!$S$16:$X$17</c:f>
              <c:multiLvlStrCache>
                <c:ptCount val="6"/>
                <c:lvl>
                  <c:pt idx="0">
                    <c:v>30h</c:v>
                  </c:pt>
                  <c:pt idx="1">
                    <c:v>40h</c:v>
                  </c:pt>
                  <c:pt idx="2">
                    <c:v>54h</c:v>
                  </c:pt>
                  <c:pt idx="3">
                    <c:v>30h</c:v>
                  </c:pt>
                  <c:pt idx="4">
                    <c:v>40h</c:v>
                  </c:pt>
                  <c:pt idx="5">
                    <c:v>54h</c:v>
                  </c:pt>
                </c:lvl>
                <c:lvl>
                  <c:pt idx="0">
                    <c:v>25°C</c:v>
                  </c:pt>
                  <c:pt idx="3">
                    <c:v>35°C</c:v>
                  </c:pt>
                </c:lvl>
              </c:multiLvlStrCache>
            </c:multiLvlStrRef>
          </c:cat>
          <c:val>
            <c:numRef>
              <c:f>Sheet1!$S$18:$X$18</c:f>
              <c:numCache>
                <c:formatCode>General</c:formatCode>
                <c:ptCount val="6"/>
                <c:pt idx="0">
                  <c:v>1</c:v>
                </c:pt>
                <c:pt idx="1">
                  <c:v>1.6161994</c:v>
                </c:pt>
                <c:pt idx="2">
                  <c:v>2.0095963999999999</c:v>
                </c:pt>
                <c:pt idx="3">
                  <c:v>2.5610797999999999</c:v>
                </c:pt>
                <c:pt idx="4">
                  <c:v>4.1561425999999981</c:v>
                </c:pt>
                <c:pt idx="5">
                  <c:v>2.7796205999999999</c:v>
                </c:pt>
              </c:numCache>
            </c:numRef>
          </c:val>
        </c:ser>
        <c:ser>
          <c:idx val="1"/>
          <c:order val="1"/>
          <c:tx>
            <c:strRef>
              <c:f>Sheet1!$R$19</c:f>
              <c:strCache>
                <c:ptCount val="1"/>
                <c:pt idx="0">
                  <c:v>Triacylglycerol Lipase RNA Seq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multiLvlStrRef>
              <c:f>Sheet1!$S$16:$X$17</c:f>
              <c:multiLvlStrCache>
                <c:ptCount val="6"/>
                <c:lvl>
                  <c:pt idx="0">
                    <c:v>30h</c:v>
                  </c:pt>
                  <c:pt idx="1">
                    <c:v>40h</c:v>
                  </c:pt>
                  <c:pt idx="2">
                    <c:v>54h</c:v>
                  </c:pt>
                  <c:pt idx="3">
                    <c:v>30h</c:v>
                  </c:pt>
                  <c:pt idx="4">
                    <c:v>40h</c:v>
                  </c:pt>
                  <c:pt idx="5">
                    <c:v>54h</c:v>
                  </c:pt>
                </c:lvl>
                <c:lvl>
                  <c:pt idx="0">
                    <c:v>25°C</c:v>
                  </c:pt>
                  <c:pt idx="3">
                    <c:v>35°C</c:v>
                  </c:pt>
                </c:lvl>
              </c:multiLvlStrCache>
            </c:multiLvlStrRef>
          </c:cat>
          <c:val>
            <c:numRef>
              <c:f>Sheet1!$S$19:$X$19</c:f>
              <c:numCache>
                <c:formatCode>General</c:formatCode>
                <c:ptCount val="6"/>
                <c:pt idx="0">
                  <c:v>1</c:v>
                </c:pt>
                <c:pt idx="1">
                  <c:v>1.3637943059999993</c:v>
                </c:pt>
                <c:pt idx="2">
                  <c:v>1.6795716369999998</c:v>
                </c:pt>
                <c:pt idx="3">
                  <c:v>2.8522368509999998</c:v>
                </c:pt>
                <c:pt idx="4">
                  <c:v>4.6499953569999963</c:v>
                </c:pt>
                <c:pt idx="5">
                  <c:v>4.95239613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3400440"/>
        <c:axId val="193400832"/>
      </c:barChart>
      <c:catAx>
        <c:axId val="1934004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193400832"/>
        <c:crosses val="autoZero"/>
        <c:auto val="1"/>
        <c:lblAlgn val="ctr"/>
        <c:lblOffset val="100"/>
        <c:noMultiLvlLbl val="0"/>
      </c:catAx>
      <c:valAx>
        <c:axId val="19340083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 b="0">
                    <a:latin typeface="Helvetica" panose="020B0604020202020204" pitchFamily="34" charset="0"/>
                    <a:cs typeface="Helvetica" panose="020B0604020202020204" pitchFamily="34" charset="0"/>
                  </a:defRPr>
                </a:pPr>
                <a:r>
                  <a:rPr lang="en-US" sz="800" b="0">
                    <a:latin typeface="Helvetica" panose="020B0604020202020204" pitchFamily="34" charset="0"/>
                    <a:cs typeface="Helvetica" panose="020B0604020202020204" pitchFamily="34" charset="0"/>
                  </a:rPr>
                  <a:t>Expression Level</a:t>
                </a:r>
              </a:p>
            </c:rich>
          </c:tx>
          <c:layout>
            <c:manualLayout>
              <c:xMode val="edge"/>
              <c:yMode val="edge"/>
              <c:x val="1.0404627355608662E-2"/>
              <c:y val="0.2562019223860639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en-US"/>
          </a:p>
        </c:txPr>
        <c:crossAx val="19340044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9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F0638EF7-21BA-46D6-B331-2665E60F3993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1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9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8A23745D-2A52-4D76-8184-F020C4DF11F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2635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23745D-2A52-4D76-8184-F020C4DF11F2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0025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457200" y="6096000"/>
            <a:ext cx="60960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8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Figure. Expression of genes determined by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qPCR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matches expression determined from transcriptome assembly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  Genes encoding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adenylate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cyclas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triacylglycerol lipase, and sodium phosphate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symporter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were determined to be differentially expressed in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D. viridi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when exposed to increased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emperature under continuous light. 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Real-time PCR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esting of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these genes at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30, 40,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54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hours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under 25°C and 35°C conditions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revealed expression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gray bar) which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is similar to expression of the same genes determined from the transcriptom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ssembly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black bar). </a:t>
            </a:r>
            <a:r>
              <a:rPr lang="en-US" sz="1200" dirty="0">
                <a:latin typeface="Times New Roman" panose="02020603050405020304" pitchFamily="18" charset="0"/>
                <a:cs typeface="Times New Roman" pitchFamily="18" charset="0"/>
              </a:rPr>
              <a:t>The error bars represent the standard deviation from three </a:t>
            </a:r>
            <a:r>
              <a:rPr lang="en-US" sz="1200">
                <a:latin typeface="Times New Roman" panose="02020603050405020304" pitchFamily="18" charset="0"/>
                <a:cs typeface="Times New Roman" pitchFamily="18" charset="0"/>
              </a:rPr>
              <a:t>independent </a:t>
            </a:r>
            <a:r>
              <a:rPr lang="en-US" sz="1200" smtClean="0">
                <a:latin typeface="Times New Roman" panose="02020603050405020304" pitchFamily="18" charset="0"/>
                <a:cs typeface="Times New Roman" pitchFamily="18" charset="0"/>
              </a:rPr>
              <a:t>biological replicates</a:t>
            </a:r>
            <a:r>
              <a:rPr lang="en-US" sz="1200" dirty="0">
                <a:latin typeface="Times New Roman" panose="02020603050405020304" pitchFamily="18" charset="0"/>
                <a:cs typeface="Times New Roman" pitchFamily="18" charset="0"/>
              </a:rPr>
              <a:t>. </a:t>
            </a:r>
          </a:p>
        </p:txBody>
      </p:sp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15693436"/>
              </p:ext>
            </p:extLst>
          </p:nvPr>
        </p:nvGraphicFramePr>
        <p:xfrm>
          <a:off x="685801" y="838200"/>
          <a:ext cx="2819399" cy="2209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4048772"/>
              </p:ext>
            </p:extLst>
          </p:nvPr>
        </p:nvGraphicFramePr>
        <p:xfrm>
          <a:off x="3518263" y="838200"/>
          <a:ext cx="2836687" cy="21568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99888389"/>
              </p:ext>
            </p:extLst>
          </p:nvPr>
        </p:nvGraphicFramePr>
        <p:xfrm>
          <a:off x="2055989" y="3429000"/>
          <a:ext cx="2898421" cy="21604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29439139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431</TotalTime>
  <Words>117</Words>
  <Application>Microsoft Office PowerPoint</Application>
  <PresentationFormat>On-screen Show (4:3)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wsedero</dc:creator>
  <cp:lastModifiedBy>Soundarya Srirangan</cp:lastModifiedBy>
  <cp:revision>480</cp:revision>
  <cp:lastPrinted>2014-10-28T12:32:56Z</cp:lastPrinted>
  <dcterms:created xsi:type="dcterms:W3CDTF">2012-07-19T19:41:05Z</dcterms:created>
  <dcterms:modified xsi:type="dcterms:W3CDTF">2015-02-24T14:38:04Z</dcterms:modified>
</cp:coreProperties>
</file>